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8577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558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211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5065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1138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2036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6761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8438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1281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6631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4517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35C9A-FE16-457D-BE6B-DC567B79AE7B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1FB58F-0FAD-43F3-A1BD-59B0DA0521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670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4576882" y="3133409"/>
          <a:ext cx="3038237" cy="1409746"/>
        </p:xfrm>
        <a:graphic>
          <a:graphicData uri="http://schemas.openxmlformats.org/drawingml/2006/table">
            <a:tbl>
              <a:tblPr firstRow="1" firstCol="1" bandRow="1"/>
              <a:tblGrid>
                <a:gridCol w="494705">
                  <a:extLst>
                    <a:ext uri="{9D8B030D-6E8A-4147-A177-3AD203B41FA5}">
                      <a16:colId xmlns:a16="http://schemas.microsoft.com/office/drawing/2014/main" val="3544110593"/>
                    </a:ext>
                  </a:extLst>
                </a:gridCol>
                <a:gridCol w="210026">
                  <a:extLst>
                    <a:ext uri="{9D8B030D-6E8A-4147-A177-3AD203B41FA5}">
                      <a16:colId xmlns:a16="http://schemas.microsoft.com/office/drawing/2014/main" val="3050195801"/>
                    </a:ext>
                  </a:extLst>
                </a:gridCol>
                <a:gridCol w="2333506">
                  <a:extLst>
                    <a:ext uri="{9D8B030D-6E8A-4147-A177-3AD203B41FA5}">
                      <a16:colId xmlns:a16="http://schemas.microsoft.com/office/drawing/2014/main" val="2104492623"/>
                    </a:ext>
                  </a:extLst>
                </a:gridCol>
              </a:tblGrid>
              <a:tr h="108442">
                <a:tc gridSpan="3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600" noProof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ble S1: primers used in this study.</a:t>
                      </a:r>
                      <a:endParaRPr lang="en-GB" sz="600" noProof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nl-NL" sz="11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nl-NL" sz="11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066215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cO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TTTCCCTTCTTGTGCCT</a:t>
                      </a:r>
                      <a:endParaRPr lang="nl-NL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0770758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nl-NL" sz="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GCTGATCGTCCGC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318251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DGAT1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ACATCGATCCTTTTCG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9607141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nl-NL" sz="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ATTTTGGATTCTGC</a:t>
                      </a:r>
                      <a:endParaRPr lang="nl-NL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8422216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WRI1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ACCAAATCTAAACTTTCTCAGAG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7474565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nl-NL" sz="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ACCGGCAAAGACATTGATTATTC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3063817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cWRI1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AATTCAAACAGAATAGTTACAACAAGA</a:t>
                      </a:r>
                      <a:endParaRPr lang="nl-NL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5762273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nl-NL" sz="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GAAGTAAATGAAGAGGTCTCCTACTTCC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6273922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cDGAT1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CAGTTCCCATCGCGAT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7663904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nl-NL" sz="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ACGATTCTCGAAACGC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6221579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TPS11</a:t>
                      </a:r>
                      <a:endParaRPr lang="nl-NL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nl-NL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AAAGAAGTATAGGATCTACGAGCAAAAG</a:t>
                      </a:r>
                      <a:endParaRPr lang="nl-NL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6879143"/>
                  </a:ext>
                </a:extLst>
              </a:tr>
              <a:tr h="10844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nl-NL" sz="6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nl-NL" sz="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CCATGGAAGCATTAGGAAACTTTGATTAC</a:t>
                      </a:r>
                      <a:endParaRPr lang="nl-NL" sz="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003" marR="2500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22165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711491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5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73"/>
          <a:stretch>
            <a:fillRect/>
          </a:stretch>
        </p:blipFill>
        <p:spPr bwMode="auto">
          <a:xfrm>
            <a:off x="4536876" y="948780"/>
            <a:ext cx="3011091" cy="7929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 Box 2"/>
          <p:cNvSpPr txBox="1">
            <a:spLocks noChangeArrowheads="1"/>
          </p:cNvSpPr>
          <p:nvPr/>
        </p:nvSpPr>
        <p:spPr bwMode="auto">
          <a:xfrm>
            <a:off x="4536877" y="1864521"/>
            <a:ext cx="3139678" cy="6112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nl-NL" sz="563" dirty="0">
                <a:ea typeface="Verdana" panose="020B0604030504040204" pitchFamily="34" charset="0"/>
                <a:cs typeface="Times New Roman" panose="02020603050405020304" pitchFamily="18" charset="0"/>
              </a:rPr>
              <a:t>Figure S1.</a:t>
            </a:r>
            <a:r>
              <a:rPr lang="en-GB" altLang="nl-NL" sz="563" b="1" dirty="0">
                <a:solidFill>
                  <a:srgbClr val="4F81BD"/>
                </a:solidFill>
                <a:ea typeface="Verdan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GB" altLang="nl-NL" sz="563" dirty="0">
                <a:ea typeface="Verdana" panose="020B0604030504040204" pitchFamily="34" charset="0"/>
                <a:cs typeface="Times New Roman" panose="02020603050405020304" pitchFamily="18" charset="0"/>
              </a:rPr>
              <a:t>TLC plates with iodine staining (black and white </a:t>
            </a:r>
            <a:r>
              <a:rPr lang="en-GB" altLang="nl-NL" sz="563" dirty="0">
                <a:solidFill>
                  <a:srgbClr val="000000"/>
                </a:solidFill>
                <a:ea typeface="Verdana" panose="020B0604030504040204" pitchFamily="34" charset="0"/>
                <a:cs typeface="Times New Roman" panose="02020603050405020304" pitchFamily="18" charset="0"/>
              </a:rPr>
              <a:t>filter) of leaf extract samples at 7 DPI: (a) empty vector, (b) RcO1+RcDGAT1, (c) RcO+AtDGAT1, (d) RcO+AtDGAT1+RcWRI1, (e) RcO+RcDGAT1+RcWRI1. Each plate from the left to the right two virgin olive oil samples (100 and 1000 time diluted in chloroform) then a WT followed by 5 or 4 samples.</a:t>
            </a:r>
            <a:endParaRPr lang="en-GB" altLang="nl-NL" sz="563" dirty="0"/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en-GB" altLang="nl-NL" sz="563" dirty="0"/>
          </a:p>
        </p:txBody>
      </p:sp>
      <p:sp>
        <p:nvSpPr>
          <p:cNvPr id="5" name="Text Box 1"/>
          <p:cNvSpPr txBox="1">
            <a:spLocks noChangeArrowheads="1"/>
          </p:cNvSpPr>
          <p:nvPr/>
        </p:nvSpPr>
        <p:spPr bwMode="auto">
          <a:xfrm>
            <a:off x="4536877" y="944315"/>
            <a:ext cx="205383" cy="149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pPr algn="just"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nl-NL" sz="506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endParaRPr lang="en-GB" altLang="nl-NL" sz="1013" dirty="0">
              <a:latin typeface="Arial" panose="020B0604020202020204" pitchFamily="34" charset="0"/>
            </a:endParaRPr>
          </a:p>
        </p:txBody>
      </p:sp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5151239" y="944315"/>
            <a:ext cx="208955" cy="1410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pPr algn="just"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nl-NL" sz="506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endParaRPr lang="en-GB" altLang="nl-NL" sz="1013" dirty="0">
              <a:latin typeface="Arial" panose="020B0604020202020204" pitchFamily="34" charset="0"/>
            </a:endParaRPr>
          </a:p>
        </p:txBody>
      </p:sp>
      <p:sp>
        <p:nvSpPr>
          <p:cNvPr id="7" name="Text Box 3"/>
          <p:cNvSpPr txBox="1">
            <a:spLocks noChangeArrowheads="1"/>
          </p:cNvSpPr>
          <p:nvPr/>
        </p:nvSpPr>
        <p:spPr bwMode="auto">
          <a:xfrm>
            <a:off x="5713810" y="948333"/>
            <a:ext cx="244673" cy="1410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pPr algn="ctr"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nl-NL" sz="506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endParaRPr lang="en-GB" altLang="nl-NL" sz="1013" dirty="0">
              <a:latin typeface="Arial" panose="020B0604020202020204" pitchFamily="34" charset="0"/>
            </a:endParaRPr>
          </a:p>
        </p:txBody>
      </p:sp>
      <p:sp>
        <p:nvSpPr>
          <p:cNvPr id="8" name="Text Box 4"/>
          <p:cNvSpPr txBox="1">
            <a:spLocks noChangeArrowheads="1"/>
          </p:cNvSpPr>
          <p:nvPr/>
        </p:nvSpPr>
        <p:spPr bwMode="auto">
          <a:xfrm>
            <a:off x="6319242" y="940296"/>
            <a:ext cx="216991" cy="149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pPr algn="ctr"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nl-NL" sz="506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endParaRPr lang="en-GB" altLang="nl-NL" sz="1013" dirty="0">
              <a:latin typeface="Arial" panose="020B0604020202020204" pitchFamily="34" charset="0"/>
            </a:endParaRPr>
          </a:p>
        </p:txBody>
      </p:sp>
      <p:sp>
        <p:nvSpPr>
          <p:cNvPr id="9" name="Text Box 5"/>
          <p:cNvSpPr txBox="1">
            <a:spLocks noChangeArrowheads="1"/>
          </p:cNvSpPr>
          <p:nvPr/>
        </p:nvSpPr>
        <p:spPr bwMode="auto">
          <a:xfrm>
            <a:off x="6910387" y="939850"/>
            <a:ext cx="292894" cy="1535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pPr algn="ctr"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nl-NL" sz="506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e)</a:t>
            </a:r>
            <a:endParaRPr lang="en-GB" altLang="nl-NL" sz="1013" dirty="0">
              <a:latin typeface="Arial" panose="020B0604020202020204" pitchFamily="34" charset="0"/>
            </a:endParaRPr>
          </a:p>
        </p:txBody>
      </p:sp>
      <p:sp>
        <p:nvSpPr>
          <p:cNvPr id="11" name="Rectangle 9"/>
          <p:cNvSpPr>
            <a:spLocks noChangeArrowheads="1"/>
          </p:cNvSpPr>
          <p:nvPr/>
        </p:nvSpPr>
        <p:spPr bwMode="auto">
          <a:xfrm>
            <a:off x="4536877" y="1569839"/>
            <a:ext cx="0" cy="0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en-GB" sz="1013"/>
          </a:p>
        </p:txBody>
      </p:sp>
      <p:sp>
        <p:nvSpPr>
          <p:cNvPr id="12" name="Rectangle 16"/>
          <p:cNvSpPr>
            <a:spLocks noChangeArrowheads="1"/>
          </p:cNvSpPr>
          <p:nvPr/>
        </p:nvSpPr>
        <p:spPr bwMode="auto">
          <a:xfrm>
            <a:off x="4271559" y="-64"/>
            <a:ext cx="198452" cy="242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51435" tIns="25718" rIns="51435" bIns="25718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514350" eaLnBrk="0" fontAlgn="base" hangingPunct="0">
              <a:spcBef>
                <a:spcPct val="0"/>
              </a:spcBef>
              <a:spcAft>
                <a:spcPct val="0"/>
              </a:spcAft>
            </a:pPr>
            <a:endParaRPr lang="en-GB" altLang="nl-NL" sz="619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nl-NL" sz="619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 </a:t>
            </a:r>
            <a:endParaRPr lang="en-GB" altLang="nl-NL" sz="1013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59659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4604779" y="4115958"/>
            <a:ext cx="2893219" cy="65973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51435" tIns="25718" rIns="51435" bIns="25718" anchor="t" anchorCtr="0">
            <a:spAutoFit/>
          </a:bodyPr>
          <a:lstStyle/>
          <a:p>
            <a:pPr algn="just">
              <a:lnSpc>
                <a:spcPct val="115000"/>
              </a:lnSpc>
              <a:spcAft>
                <a:spcPts val="563"/>
              </a:spcAft>
            </a:pPr>
            <a:r>
              <a:rPr lang="en-GB" sz="619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619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2. Mesophyll cells by light microscopy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ght microscopy images of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nthamiana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aves (at 7 DPI) after Sudan IV 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ining (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rom RcO+AtDGAT1+RcWRI1, (b) </a:t>
            </a:r>
            <a:r>
              <a:rPr lang="en-GB" sz="563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aBOS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(c) AaBOS+RcO+AtDGAT1+RcWRI1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Blue arrows indicate lipid bodies; bars correspond to 20µm 40µm and 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µm respectively. </a:t>
            </a:r>
            <a:r>
              <a:rPr lang="en-GB" sz="563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cO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cinus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munis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LE1; AtDGAT1 =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abidopsis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aliana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63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cylglycerol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ferase; RcWRI1=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cinus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munis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RINKL1; </a:t>
            </a:r>
            <a:r>
              <a:rPr lang="en-GB" sz="563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aBOS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=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temisia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563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nua</a:t>
            </a:r>
            <a:r>
              <a:rPr lang="en-GB" sz="56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isabolol synthase.</a:t>
            </a:r>
            <a:endParaRPr lang="nl-NL" sz="563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7" name="Group 36"/>
          <p:cNvGrpSpPr/>
          <p:nvPr/>
        </p:nvGrpSpPr>
        <p:grpSpPr>
          <a:xfrm>
            <a:off x="4475317" y="3249270"/>
            <a:ext cx="3237868" cy="823566"/>
            <a:chOff x="165232" y="5822199"/>
            <a:chExt cx="5756209" cy="1464118"/>
          </a:xfrm>
        </p:grpSpPr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2"/>
            <a:srcRect t="4981" r="1269"/>
            <a:stretch/>
          </p:blipFill>
          <p:spPr>
            <a:xfrm>
              <a:off x="2071215" y="5861479"/>
              <a:ext cx="1900646" cy="1424838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05788" y="5861479"/>
              <a:ext cx="1915653" cy="1424838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5232" y="5861479"/>
              <a:ext cx="1872056" cy="1416499"/>
            </a:xfrm>
            <a:prstGeom prst="rect">
              <a:avLst/>
            </a:prstGeom>
          </p:spPr>
        </p:pic>
        <p:sp>
          <p:nvSpPr>
            <p:cNvPr id="34" name="TextBox 33"/>
            <p:cNvSpPr txBox="1"/>
            <p:nvPr/>
          </p:nvSpPr>
          <p:spPr>
            <a:xfrm>
              <a:off x="165232" y="5822199"/>
              <a:ext cx="542990" cy="995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13" dirty="0">
                  <a:solidFill>
                    <a:schemeClr val="bg1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nl-NL" sz="900" dirty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endParaRPr lang="en-GB" sz="1013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968885" y="5861479"/>
              <a:ext cx="542990" cy="995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13" dirty="0">
                  <a:solidFill>
                    <a:schemeClr val="bg1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lang="nl-NL" sz="900" dirty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endParaRPr lang="en-GB" sz="1013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044434" y="5861479"/>
              <a:ext cx="542990" cy="995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13" dirty="0">
                  <a:solidFill>
                    <a:schemeClr val="bg1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nl-NL" sz="900" dirty="0">
                <a:solidFill>
                  <a:schemeClr val="bg1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endParaRPr lang="en-GB" sz="1013" dirty="0"/>
            </a:p>
          </p:txBody>
        </p:sp>
      </p:grpSp>
      <p:sp>
        <p:nvSpPr>
          <p:cNvPr id="38" name="Down Arrow 37"/>
          <p:cNvSpPr/>
          <p:nvPr/>
        </p:nvSpPr>
        <p:spPr>
          <a:xfrm>
            <a:off x="4834236" y="3725019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39" name="Down Arrow 38"/>
          <p:cNvSpPr/>
          <p:nvPr/>
        </p:nvSpPr>
        <p:spPr>
          <a:xfrm>
            <a:off x="4882519" y="3714304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0" name="Down Arrow 39"/>
          <p:cNvSpPr/>
          <p:nvPr/>
        </p:nvSpPr>
        <p:spPr>
          <a:xfrm>
            <a:off x="4780750" y="3879057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1" name="Down Arrow 40"/>
          <p:cNvSpPr/>
          <p:nvPr/>
        </p:nvSpPr>
        <p:spPr>
          <a:xfrm>
            <a:off x="5453467" y="3527769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2" name="Down Arrow 41"/>
          <p:cNvSpPr/>
          <p:nvPr/>
        </p:nvSpPr>
        <p:spPr>
          <a:xfrm>
            <a:off x="5028095" y="3499641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3" name="Down Arrow 42"/>
          <p:cNvSpPr/>
          <p:nvPr/>
        </p:nvSpPr>
        <p:spPr>
          <a:xfrm>
            <a:off x="5285631" y="3301752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4" name="Down Arrow 43"/>
          <p:cNvSpPr/>
          <p:nvPr/>
        </p:nvSpPr>
        <p:spPr>
          <a:xfrm>
            <a:off x="5415558" y="3686175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5" name="Down Arrow 44"/>
          <p:cNvSpPr/>
          <p:nvPr/>
        </p:nvSpPr>
        <p:spPr>
          <a:xfrm>
            <a:off x="4976116" y="3606797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6" name="Down Arrow 45"/>
          <p:cNvSpPr/>
          <p:nvPr/>
        </p:nvSpPr>
        <p:spPr>
          <a:xfrm>
            <a:off x="5053812" y="3684834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7" name="Down Arrow 46"/>
          <p:cNvSpPr/>
          <p:nvPr/>
        </p:nvSpPr>
        <p:spPr>
          <a:xfrm>
            <a:off x="4942448" y="3746448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8" name="Down Arrow 47"/>
          <p:cNvSpPr/>
          <p:nvPr/>
        </p:nvSpPr>
        <p:spPr>
          <a:xfrm>
            <a:off x="4869660" y="3526428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49" name="Down Arrow 48"/>
          <p:cNvSpPr/>
          <p:nvPr/>
        </p:nvSpPr>
        <p:spPr>
          <a:xfrm>
            <a:off x="5167546" y="3487586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50" name="Down Arrow 49"/>
          <p:cNvSpPr/>
          <p:nvPr/>
        </p:nvSpPr>
        <p:spPr>
          <a:xfrm>
            <a:off x="6654956" y="3781277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51" name="Down Arrow 50"/>
          <p:cNvSpPr/>
          <p:nvPr/>
        </p:nvSpPr>
        <p:spPr>
          <a:xfrm>
            <a:off x="6939388" y="3425016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52" name="Down Arrow 51"/>
          <p:cNvSpPr/>
          <p:nvPr/>
        </p:nvSpPr>
        <p:spPr>
          <a:xfrm>
            <a:off x="7092085" y="3556574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53" name="Down Arrow 52"/>
          <p:cNvSpPr/>
          <p:nvPr/>
        </p:nvSpPr>
        <p:spPr>
          <a:xfrm>
            <a:off x="7208618" y="3641626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54" name="Down Arrow 53"/>
          <p:cNvSpPr/>
          <p:nvPr/>
        </p:nvSpPr>
        <p:spPr>
          <a:xfrm>
            <a:off x="7515353" y="3549198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55" name="Down Arrow 54"/>
          <p:cNvSpPr/>
          <p:nvPr/>
        </p:nvSpPr>
        <p:spPr>
          <a:xfrm>
            <a:off x="7393617" y="3358010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56" name="Down Arrow 55"/>
          <p:cNvSpPr/>
          <p:nvPr/>
        </p:nvSpPr>
        <p:spPr>
          <a:xfrm>
            <a:off x="7096147" y="3357712"/>
            <a:ext cx="25717" cy="56257"/>
          </a:xfrm>
          <a:prstGeom prst="down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</p:spTree>
    <p:extLst>
      <p:ext uri="{BB962C8B-B14F-4D97-AF65-F5344CB8AC3E}">
        <p14:creationId xmlns:p14="http://schemas.microsoft.com/office/powerpoint/2010/main" val="18715222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http://emboss.bioinformatics.nl/emboss-explorer/output/402703/epestfind.1.pn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45"/>
          <a:stretch/>
        </p:blipFill>
        <p:spPr bwMode="auto">
          <a:xfrm>
            <a:off x="4267557" y="841177"/>
            <a:ext cx="1834515" cy="1683271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http://emboss.bioinformatics.nl/emboss-explorer/output/079745/epestfind.1.pn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19"/>
          <a:stretch/>
        </p:blipFill>
        <p:spPr bwMode="auto">
          <a:xfrm>
            <a:off x="5939909" y="835819"/>
            <a:ext cx="1870234" cy="1723991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4267558" y="2524448"/>
            <a:ext cx="3486149" cy="5254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563" dirty="0"/>
              <a:t>Figure </a:t>
            </a:r>
            <a:r>
              <a:rPr lang="en-GB" sz="563" dirty="0"/>
              <a:t>S3. </a:t>
            </a:r>
            <a:r>
              <a:rPr lang="en-GB" sz="563" dirty="0"/>
              <a:t>PEST score estimation. Using the PEST domain prediction tool </a:t>
            </a:r>
            <a:r>
              <a:rPr lang="en-GB" sz="563" dirty="0" err="1"/>
              <a:t>EpestFind</a:t>
            </a:r>
            <a:r>
              <a:rPr lang="en-GB" sz="563" dirty="0"/>
              <a:t> (http://emboss.bioinformatics.nl/cgi-bin/emboss/epestfind) for AtWRI1 and RcWRI1. The PEST domain of AtWRI1 starts at residue 398. Arabidopsis AtWRI1 has a score of 9.7 in the C-terminal domain, indicating a PEST domain, while Castor bean RcWRI1 has a score of -1.5 in the homologous region. </a:t>
            </a:r>
            <a:r>
              <a:rPr lang="en-GB" sz="563" dirty="0"/>
              <a:t>AtWRI1 </a:t>
            </a:r>
            <a:r>
              <a:rPr lang="en-GB" sz="563" dirty="0"/>
              <a:t>= </a:t>
            </a:r>
            <a:r>
              <a:rPr lang="en-GB" sz="563" i="1" dirty="0"/>
              <a:t>Arabidopsis </a:t>
            </a:r>
            <a:r>
              <a:rPr lang="en-GB" sz="563" i="1" dirty="0"/>
              <a:t>thaliana </a:t>
            </a:r>
            <a:r>
              <a:rPr lang="en-GB" sz="563" dirty="0"/>
              <a:t>WRINKL1; </a:t>
            </a:r>
            <a:r>
              <a:rPr lang="en-GB" sz="563" dirty="0"/>
              <a:t>RcWRI1= </a:t>
            </a:r>
            <a:r>
              <a:rPr lang="en-GB" sz="563" i="1" dirty="0"/>
              <a:t>Ricinus communis </a:t>
            </a:r>
            <a:r>
              <a:rPr lang="en-GB" sz="563" dirty="0"/>
              <a:t>WRINKL1.</a:t>
            </a:r>
            <a:endParaRPr lang="en-GB" sz="563" dirty="0"/>
          </a:p>
        </p:txBody>
      </p:sp>
      <p:sp>
        <p:nvSpPr>
          <p:cNvPr id="7" name="TextBox 6"/>
          <p:cNvSpPr txBox="1"/>
          <p:nvPr/>
        </p:nvSpPr>
        <p:spPr>
          <a:xfrm>
            <a:off x="4267557" y="146957"/>
            <a:ext cx="332337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13" dirty="0"/>
              <a:t>S2</a:t>
            </a:r>
            <a:endParaRPr lang="en-GB" sz="1013" dirty="0"/>
          </a:p>
        </p:txBody>
      </p:sp>
      <p:sp>
        <p:nvSpPr>
          <p:cNvPr id="2" name="TextBox 1"/>
          <p:cNvSpPr txBox="1"/>
          <p:nvPr/>
        </p:nvSpPr>
        <p:spPr>
          <a:xfrm>
            <a:off x="6566952" y="701940"/>
            <a:ext cx="61614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13" dirty="0"/>
              <a:t>RcWRI1</a:t>
            </a:r>
            <a:endParaRPr lang="en-GB" sz="1013" dirty="0"/>
          </a:p>
        </p:txBody>
      </p:sp>
      <p:sp>
        <p:nvSpPr>
          <p:cNvPr id="8" name="TextBox 7"/>
          <p:cNvSpPr txBox="1"/>
          <p:nvPr/>
        </p:nvSpPr>
        <p:spPr>
          <a:xfrm>
            <a:off x="4876741" y="701940"/>
            <a:ext cx="616148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13" dirty="0"/>
              <a:t>AtWRI1</a:t>
            </a:r>
            <a:endParaRPr lang="en-GB" sz="1013" dirty="0"/>
          </a:p>
        </p:txBody>
      </p:sp>
    </p:spTree>
    <p:extLst>
      <p:ext uri="{BB962C8B-B14F-4D97-AF65-F5344CB8AC3E}">
        <p14:creationId xmlns:p14="http://schemas.microsoft.com/office/powerpoint/2010/main" val="2835379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9</Words>
  <Application>Microsoft Office PowerPoint</Application>
  <PresentationFormat>Widescreen</PresentationFormat>
  <Paragraphs>4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Verdana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Wageningen University and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atte, Thierry</dc:creator>
  <cp:lastModifiedBy>Delatte, Thierry</cp:lastModifiedBy>
  <cp:revision>1</cp:revision>
  <dcterms:created xsi:type="dcterms:W3CDTF">2018-03-19T10:44:18Z</dcterms:created>
  <dcterms:modified xsi:type="dcterms:W3CDTF">2018-03-19T10:44:43Z</dcterms:modified>
</cp:coreProperties>
</file>